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200" d="100"/>
          <a:sy n="200" d="100"/>
        </p:scale>
        <p:origin x="-7915" y="-24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D47437-F5E6-1039-53A6-0B8434A934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58C80AA-4CB7-E0F9-409A-B441D927A0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D01C47-DED3-B44E-263D-E615DFA0B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FDF-94D5-4392-8673-0E91C2409872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033CE-8B7D-BF47-79B6-3DEF621A4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34862A-5E69-C14E-F8A7-8555C523D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D190-EF6B-4418-A609-F4A3EFE60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010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0FFBFA-C2F9-E930-EC7D-21ADA7D0B2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EEEEC8-B270-F1DF-D97E-2AA73ED68F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972479-1B8E-E4CC-6D16-010307EC37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FDF-94D5-4392-8673-0E91C2409872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6723BD-7E29-D660-77A3-EC053E6E40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29AA94-D009-A0D7-9AE9-78A1F2C5C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D190-EF6B-4418-A609-F4A3EFE60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6802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08F3047-1F22-FD06-0B34-6D9F26881E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284BD1-8454-E984-33A9-B4C3327DE9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8EF899-F1F4-ACCF-A85F-199159564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FDF-94D5-4392-8673-0E91C2409872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E95B6B-D14E-86D0-E53D-CE3EE3C42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9BDBEE-FFBF-6B0B-664F-38F014016D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D190-EF6B-4418-A609-F4A3EFE60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754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62230-3026-0794-366D-C46646F6F0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1CA160-CC77-90F7-8BF0-0AAB5CF9D6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B4A03A-A472-55BD-5380-75E9858A72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FDF-94D5-4392-8673-0E91C2409872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F13C0F-2FF0-30F9-3F10-270414964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185F83-9537-010E-FCA7-A2BB086B3F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D190-EF6B-4418-A609-F4A3EFE60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646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18949-96BC-D7DB-ED71-DFF1C7CFDA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ACAF5A-C326-F237-04E3-3D0689F6A3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CCEF06-7744-970C-D0B6-D65926804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FDF-94D5-4392-8673-0E91C2409872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5596DC-DB5E-C207-33DA-D1389EE56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C731BD-DEEC-90B7-62B2-1C3E896E8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D190-EF6B-4418-A609-F4A3EFE60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987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28E98C-EE2E-77E4-CBFB-1526735AB2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6B2D00-0B85-AF90-83FC-C14E85A517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93DB3B-B0CB-5E15-5C06-561CE61152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14258F-CD4B-E590-D690-824C1543B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FDF-94D5-4392-8673-0E91C2409872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143D81-9695-5CC0-0543-E24CEEEB9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306A95-946A-23EC-A21D-4836B9A9AF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D190-EF6B-4418-A609-F4A3EFE60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7738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24E5D0-DE7B-E6C7-2DA3-CCD7FFA4BE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55C40A-495C-CD7D-EECB-6B1A5F0DC1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535EA6-52C7-9B7C-D094-AA47126C61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89CE9C-E631-3A60-BC3A-7C4FB00767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BD5DE0-ED6E-3F7D-1C00-CB7DE263A1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D37B2D2-241E-1ED2-9307-F2150F826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FDF-94D5-4392-8673-0E91C2409872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E722B1-4151-3D3B-9941-22D7E1883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4BC0FA-ED70-A157-73D3-729798BBF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D190-EF6B-4418-A609-F4A3EFE60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219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6F8658-E9E9-A5F0-9C29-89C23F9C2E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E40256-0DF0-9834-FF6B-5FE3B84ECE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FDF-94D5-4392-8673-0E91C2409872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A622616-A973-1509-D445-2BE319C4F1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9011905-47ED-6DEE-953F-04AD347ED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D190-EF6B-4418-A609-F4A3EFE60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203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D02C920-4B4A-83A9-B6E9-2137D14A3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FDF-94D5-4392-8673-0E91C2409872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25D258D-1E02-6C8C-5621-461A453DAF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69DEE29-4038-58FC-574D-79FFDC614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D190-EF6B-4418-A609-F4A3EFE60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5844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9D42EC-B52B-4214-065D-F60A4B66CA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013A07-AC6D-4C88-2138-7852F80F83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A41A7D-6C5A-8567-36BA-F0411BA046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E22B2F-F54F-C397-717E-C94E93DA9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FDF-94D5-4392-8673-0E91C2409872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ABD2C6-0774-2BDC-816E-3E16F4ED2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C9572F-1B81-A389-5382-F5F46D215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D190-EF6B-4418-A609-F4A3EFE60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525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03A2A7-5002-FFFE-FD7E-3207C2480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287A04-71E3-513C-C5AF-81F3EDE7F5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7E6534-37D8-EC4C-3F85-2BA3BCCE92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440C65-DD11-9B5A-1871-4CE7C8918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FDF-94D5-4392-8673-0E91C2409872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CDE23E-C5BA-BE0B-E8F3-42AF40A59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1BC1DD-7756-0C6A-ECE3-6F4224E9B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6D190-EF6B-4418-A609-F4A3EFE60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959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E018254-F1BE-E88A-9817-A89B3F6CDC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430D0-AFDB-E4A0-3E1E-BB49FA0F38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F4526B-0973-CC03-FAF1-9C88E8CD29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7A3FDF-94D5-4392-8673-0E91C2409872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0830A4-6B99-16D0-AEE8-8A186F6F65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C85E20-F514-3C27-1631-0DD7CF31CA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A6D190-EF6B-4418-A609-F4A3EFE601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967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321CE43-8ACE-B158-9417-4DCB970AF64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500" t="15044" r="33014" b="36202"/>
          <a:stretch/>
        </p:blipFill>
        <p:spPr>
          <a:xfrm>
            <a:off x="7080742" y="1077998"/>
            <a:ext cx="4415086" cy="454051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0EF59A6-19FE-15D6-3752-7F7FC009A06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204" t="15266" r="30583" b="35980"/>
          <a:stretch/>
        </p:blipFill>
        <p:spPr>
          <a:xfrm>
            <a:off x="798255" y="1105834"/>
            <a:ext cx="4755442" cy="4572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EF22EA2-FB53-8F07-1DCD-1496BEB4E91B}"/>
              </a:ext>
            </a:extLst>
          </p:cNvPr>
          <p:cNvSpPr txBox="1"/>
          <p:nvPr/>
        </p:nvSpPr>
        <p:spPr>
          <a:xfrm>
            <a:off x="3498743" y="916620"/>
            <a:ext cx="8991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light sensing and signali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2116A41-D548-6C05-EE12-F04CF3281279}"/>
              </a:ext>
            </a:extLst>
          </p:cNvPr>
          <p:cNvSpPr txBox="1"/>
          <p:nvPr/>
        </p:nvSpPr>
        <p:spPr>
          <a:xfrm>
            <a:off x="9734550" y="923689"/>
            <a:ext cx="8953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light sensing and signalin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14C7EE6-1EAC-9CDD-71AE-7B85774001F0}"/>
              </a:ext>
            </a:extLst>
          </p:cNvPr>
          <p:cNvSpPr txBox="1"/>
          <p:nvPr/>
        </p:nvSpPr>
        <p:spPr>
          <a:xfrm>
            <a:off x="2603393" y="827055"/>
            <a:ext cx="8953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replication and partitio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B8981BD-895B-7ADD-0170-98ACB1B52CF0}"/>
              </a:ext>
            </a:extLst>
          </p:cNvPr>
          <p:cNvSpPr txBox="1"/>
          <p:nvPr/>
        </p:nvSpPr>
        <p:spPr>
          <a:xfrm>
            <a:off x="8914191" y="842295"/>
            <a:ext cx="8953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replication and partiti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29ECEE6-B8A8-ABB3-B00E-D6E9DD6D4A6C}"/>
              </a:ext>
            </a:extLst>
          </p:cNvPr>
          <p:cNvSpPr txBox="1"/>
          <p:nvPr/>
        </p:nvSpPr>
        <p:spPr>
          <a:xfrm>
            <a:off x="1471311" y="952785"/>
            <a:ext cx="10882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ugar transport and metabolis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B56B191-CAD9-2BF8-CB33-265F0C1AD128}"/>
              </a:ext>
            </a:extLst>
          </p:cNvPr>
          <p:cNvSpPr txBox="1"/>
          <p:nvPr/>
        </p:nvSpPr>
        <p:spPr>
          <a:xfrm>
            <a:off x="7797349" y="956595"/>
            <a:ext cx="10882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ugar transport and metabolism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B8DD5DF-F323-D3FE-D065-2D40790D2A74}"/>
              </a:ext>
            </a:extLst>
          </p:cNvPr>
          <p:cNvSpPr txBox="1"/>
          <p:nvPr/>
        </p:nvSpPr>
        <p:spPr>
          <a:xfrm>
            <a:off x="1067127" y="1512601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ignaling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B70F749-FBCB-FA0D-5167-5B79A1142F9B}"/>
              </a:ext>
            </a:extLst>
          </p:cNvPr>
          <p:cNvSpPr txBox="1"/>
          <p:nvPr/>
        </p:nvSpPr>
        <p:spPr>
          <a:xfrm>
            <a:off x="7313667" y="1571227"/>
            <a:ext cx="6383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signaling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351F71D-0225-8DB3-72BB-161E15ECE8E5}"/>
              </a:ext>
            </a:extLst>
          </p:cNvPr>
          <p:cNvSpPr txBox="1"/>
          <p:nvPr/>
        </p:nvSpPr>
        <p:spPr>
          <a:xfrm>
            <a:off x="158582" y="2878770"/>
            <a:ext cx="8305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cetoin biosynthesi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0F32247-C003-6728-7094-17D713AFF0E4}"/>
              </a:ext>
            </a:extLst>
          </p:cNvPr>
          <p:cNvSpPr txBox="1"/>
          <p:nvPr/>
        </p:nvSpPr>
        <p:spPr>
          <a:xfrm>
            <a:off x="6420941" y="3133695"/>
            <a:ext cx="8305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acetoin biosynthesi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8F2D29F-4EFA-3D58-9056-7C979306E996}"/>
              </a:ext>
            </a:extLst>
          </p:cNvPr>
          <p:cNvSpPr txBox="1"/>
          <p:nvPr/>
        </p:nvSpPr>
        <p:spPr>
          <a:xfrm>
            <a:off x="-24970" y="3508678"/>
            <a:ext cx="12752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efflux pump and sensor/respons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520FD33-59A5-DB87-507B-B16475856633}"/>
              </a:ext>
            </a:extLst>
          </p:cNvPr>
          <p:cNvSpPr txBox="1"/>
          <p:nvPr/>
        </p:nvSpPr>
        <p:spPr>
          <a:xfrm>
            <a:off x="6260753" y="3674762"/>
            <a:ext cx="12752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efflux pump and sensor/respons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EACB797-9427-6D91-FCB6-A387C504810D}"/>
              </a:ext>
            </a:extLst>
          </p:cNvPr>
          <p:cNvSpPr txBox="1"/>
          <p:nvPr/>
        </p:nvSpPr>
        <p:spPr>
          <a:xfrm>
            <a:off x="2281832" y="5618513"/>
            <a:ext cx="12094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/>
              <a:t>arnBCADTEF</a:t>
            </a:r>
            <a:r>
              <a:rPr lang="en-US" sz="1000" dirty="0"/>
              <a:t> gene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CF326CF-E8EF-1E73-7044-49E552DEC343}"/>
              </a:ext>
            </a:extLst>
          </p:cNvPr>
          <p:cNvSpPr txBox="1"/>
          <p:nvPr/>
        </p:nvSpPr>
        <p:spPr>
          <a:xfrm>
            <a:off x="9150095" y="5562404"/>
            <a:ext cx="11689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arnBCADTEF</a:t>
            </a:r>
            <a:r>
              <a:rPr lang="en-US" sz="1000" dirty="0"/>
              <a:t> gene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84E0508-0065-33DD-3456-E617B9F91724}"/>
              </a:ext>
            </a:extLst>
          </p:cNvPr>
          <p:cNvSpPr txBox="1"/>
          <p:nvPr/>
        </p:nvSpPr>
        <p:spPr>
          <a:xfrm>
            <a:off x="4462459" y="4949222"/>
            <a:ext cx="9513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toxin-antitoxin system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C6F8964-9CAA-24CE-7BFA-CF787B8F97E2}"/>
              </a:ext>
            </a:extLst>
          </p:cNvPr>
          <p:cNvSpPr txBox="1"/>
          <p:nvPr/>
        </p:nvSpPr>
        <p:spPr>
          <a:xfrm>
            <a:off x="10407779" y="5095188"/>
            <a:ext cx="95139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toxin-antitoxin system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4A0A1DC-98C6-0696-6788-E972D96BD968}"/>
              </a:ext>
            </a:extLst>
          </p:cNvPr>
          <p:cNvSpPr txBox="1"/>
          <p:nvPr/>
        </p:nvSpPr>
        <p:spPr>
          <a:xfrm>
            <a:off x="5392435" y="3661755"/>
            <a:ext cx="6694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iron impor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7D8DF2C-BEE5-9EEA-3B4F-3E97D102AFE0}"/>
              </a:ext>
            </a:extLst>
          </p:cNvPr>
          <p:cNvSpPr txBox="1"/>
          <p:nvPr/>
        </p:nvSpPr>
        <p:spPr>
          <a:xfrm>
            <a:off x="11329822" y="3984311"/>
            <a:ext cx="6694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iron import</a:t>
            </a:r>
          </a:p>
        </p:txBody>
      </p:sp>
      <p:sp>
        <p:nvSpPr>
          <p:cNvPr id="27" name="Right Brace 26">
            <a:extLst>
              <a:ext uri="{FF2B5EF4-FFF2-40B4-BE49-F238E27FC236}">
                <a16:creationId xmlns:a16="http://schemas.microsoft.com/office/drawing/2014/main" id="{CE92B27D-E3D3-4E2D-6F4B-F4F73192A889}"/>
              </a:ext>
            </a:extLst>
          </p:cNvPr>
          <p:cNvSpPr/>
          <p:nvPr/>
        </p:nvSpPr>
        <p:spPr>
          <a:xfrm rot="4179234">
            <a:off x="3800597" y="5090761"/>
            <a:ext cx="165621" cy="704139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DD19BD5-09EC-3EE4-D43E-3E54ED3C2ADF}"/>
              </a:ext>
            </a:extLst>
          </p:cNvPr>
          <p:cNvSpPr txBox="1"/>
          <p:nvPr/>
        </p:nvSpPr>
        <p:spPr>
          <a:xfrm rot="20336455">
            <a:off x="3589359" y="5461718"/>
            <a:ext cx="7944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HiVir gene cluster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97B439CE-1F95-5024-A780-24BCCA0A673D}"/>
              </a:ext>
            </a:extLst>
          </p:cNvPr>
          <p:cNvSpPr/>
          <p:nvPr/>
        </p:nvSpPr>
        <p:spPr>
          <a:xfrm>
            <a:off x="5930994" y="5752748"/>
            <a:ext cx="182880" cy="182880"/>
          </a:xfrm>
          <a:prstGeom prst="rect">
            <a:avLst/>
          </a:prstGeom>
          <a:solidFill>
            <a:srgbClr val="00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9B7029C5-4AEC-0CD8-38EA-E7724268B76B}"/>
              </a:ext>
            </a:extLst>
          </p:cNvPr>
          <p:cNvSpPr/>
          <p:nvPr/>
        </p:nvSpPr>
        <p:spPr>
          <a:xfrm>
            <a:off x="5930826" y="6091867"/>
            <a:ext cx="182880" cy="182880"/>
          </a:xfrm>
          <a:prstGeom prst="rect">
            <a:avLst/>
          </a:prstGeom>
          <a:solidFill>
            <a:srgbClr val="FFFF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1F886BB-8733-6C62-3137-C3B86E928757}"/>
              </a:ext>
            </a:extLst>
          </p:cNvPr>
          <p:cNvSpPr txBox="1"/>
          <p:nvPr/>
        </p:nvSpPr>
        <p:spPr>
          <a:xfrm>
            <a:off x="6060971" y="5722063"/>
            <a:ext cx="14648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ard core </a:t>
            </a:r>
            <a:r>
              <a:rPr lang="en-US" sz="1000" dirty="0" err="1"/>
              <a:t>pAggl</a:t>
            </a:r>
            <a:r>
              <a:rPr lang="en-US" sz="1000" dirty="0"/>
              <a:t> gene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C71B903-9AC5-0C49-40E9-4F14719A602C}"/>
              </a:ext>
            </a:extLst>
          </p:cNvPr>
          <p:cNvSpPr txBox="1"/>
          <p:nvPr/>
        </p:nvSpPr>
        <p:spPr>
          <a:xfrm>
            <a:off x="6060971" y="6048278"/>
            <a:ext cx="14648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lusters of hard core </a:t>
            </a:r>
            <a:r>
              <a:rPr lang="en-US" sz="1000" dirty="0" err="1"/>
              <a:t>pAggl</a:t>
            </a:r>
            <a:r>
              <a:rPr lang="en-US" sz="1000" dirty="0"/>
              <a:t> genes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76400043-DD55-B6D2-B169-171FD0D820F1}"/>
              </a:ext>
            </a:extLst>
          </p:cNvPr>
          <p:cNvSpPr/>
          <p:nvPr/>
        </p:nvSpPr>
        <p:spPr>
          <a:xfrm>
            <a:off x="5823752" y="5562404"/>
            <a:ext cx="1702056" cy="944928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1741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65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 Ann Elizabeth Asselin</dc:creator>
  <cp:lastModifiedBy>Jo Ann Elizabeth Asselin</cp:lastModifiedBy>
  <cp:revision>3</cp:revision>
  <dcterms:created xsi:type="dcterms:W3CDTF">2024-02-21T22:06:36Z</dcterms:created>
  <dcterms:modified xsi:type="dcterms:W3CDTF">2024-04-04T02:28:48Z</dcterms:modified>
</cp:coreProperties>
</file>